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58" r:id="rId2"/>
    <p:sldId id="259" r:id="rId3"/>
    <p:sldId id="260" r:id="rId4"/>
    <p:sldId id="265" r:id="rId5"/>
  </p:sldIdLst>
  <p:sldSz cx="12192000" cy="6858000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pos="3840" userDrawn="1">
          <p15:clr>
            <a:srgbClr val="A4A3A4"/>
          </p15:clr>
        </p15:guide>
        <p15:guide id="2" orient="horz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A488322-F2BA-4B5B-9748-0D474271808F}" styleName="中間スタイル 3 - アクセント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683"/>
    <p:restoredTop sz="94424" autoAdjust="0"/>
  </p:normalViewPr>
  <p:slideViewPr>
    <p:cSldViewPr snapToGrid="0" snapToObjects="1">
      <p:cViewPr varScale="1">
        <p:scale>
          <a:sx n="110" d="100"/>
          <a:sy n="110" d="100"/>
        </p:scale>
        <p:origin x="684" y="108"/>
      </p:cViewPr>
      <p:guideLst>
        <p:guide pos="3840"/>
        <p:guide orient="horz"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image" Target="../media/image3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image" Target="../media/image5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image" Target="../media/image7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2" y="2"/>
            <a:ext cx="2949786" cy="498693"/>
          </a:xfrm>
          <a:prstGeom prst="rect">
            <a:avLst/>
          </a:prstGeom>
        </p:spPr>
        <p:txBody>
          <a:bodyPr vert="horz" lIns="91550" tIns="45775" rIns="91550" bIns="45775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40" y="2"/>
            <a:ext cx="2949786" cy="498693"/>
          </a:xfrm>
          <a:prstGeom prst="rect">
            <a:avLst/>
          </a:prstGeom>
        </p:spPr>
        <p:txBody>
          <a:bodyPr vert="horz" lIns="91550" tIns="45775" rIns="91550" bIns="45775" rtlCol="0"/>
          <a:lstStyle>
            <a:lvl1pPr algn="r">
              <a:defRPr sz="1200"/>
            </a:lvl1pPr>
          </a:lstStyle>
          <a:p>
            <a:fld id="{77D33108-F554-444F-9E67-F47E2CFB0E8B}" type="datetimeFigureOut">
              <a:rPr kumimoji="1" lang="ja-JP" altLang="en-US" smtClean="0"/>
              <a:t>2019/6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23863" y="1243013"/>
            <a:ext cx="5959475" cy="33528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550" tIns="45775" rIns="91550" bIns="45775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83307"/>
            <a:ext cx="5445760" cy="3913616"/>
          </a:xfrm>
          <a:prstGeom prst="rect">
            <a:avLst/>
          </a:prstGeom>
        </p:spPr>
        <p:txBody>
          <a:bodyPr vert="horz" lIns="91550" tIns="45775" rIns="91550" bIns="45775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2" y="9440647"/>
            <a:ext cx="2949786" cy="498691"/>
          </a:xfrm>
          <a:prstGeom prst="rect">
            <a:avLst/>
          </a:prstGeom>
        </p:spPr>
        <p:txBody>
          <a:bodyPr vert="horz" lIns="91550" tIns="45775" rIns="91550" bIns="45775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40" y="9440647"/>
            <a:ext cx="2949786" cy="498691"/>
          </a:xfrm>
          <a:prstGeom prst="rect">
            <a:avLst/>
          </a:prstGeom>
        </p:spPr>
        <p:txBody>
          <a:bodyPr vert="horz" lIns="91550" tIns="45775" rIns="91550" bIns="45775" rtlCol="0" anchor="b"/>
          <a:lstStyle>
            <a:lvl1pPr algn="r">
              <a:defRPr sz="1200"/>
            </a:lvl1pPr>
          </a:lstStyle>
          <a:p>
            <a:fld id="{8044FAF7-90A7-054A-B2BF-466D2E006F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67244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044FAF7-90A7-054A-B2BF-466D2E006FE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123624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>
              <a:latin typeface="Helvetica" pitchFamily="2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044FAF7-90A7-054A-B2BF-466D2E006FE6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280471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>
              <a:latin typeface="Helvetica" pitchFamily="2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044FAF7-90A7-054A-B2BF-466D2E006FE6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84841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044FAF7-90A7-054A-B2BF-466D2E006FE6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11407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8082C3F-919D-E24C-887B-F350A71E484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589D102-668C-D94D-9535-CF1B4388F9A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AEE80EE-2AE2-544B-8E47-32DB242265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9B71D-453C-4549-A402-6A7C1028A10F}" type="datetimeFigureOut">
              <a:rPr kumimoji="1" lang="ja-JP" altLang="en-US" smtClean="0"/>
              <a:t>2019/6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3F5AB05-934A-A443-B926-82AA5BE10A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2AAA88E-E240-504A-A1FD-E9B18F4991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3FBD9-4A29-6046-B486-46FA3AD1F3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64614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8E57624-760F-3A4E-B2C7-A070EA0299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7CC58AA-F02E-F544-9DE5-AE6BF57A51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24BFF3D-5689-BB45-A10B-F3019481E8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9B71D-453C-4549-A402-6A7C1028A10F}" type="datetimeFigureOut">
              <a:rPr kumimoji="1" lang="ja-JP" altLang="en-US" smtClean="0"/>
              <a:t>2019/6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6AB6546-7F2B-6348-A587-757015AB69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44CEFD2-1625-0945-96FC-F19F589208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3FBD9-4A29-6046-B486-46FA3AD1F3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5664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15E643D-6A71-B740-A26D-887A1E86614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1EBE7A6-C469-E94C-B00B-D2384B56EF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56A65CF-1930-894B-9C5E-1C2A826626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9B71D-453C-4549-A402-6A7C1028A10F}" type="datetimeFigureOut">
              <a:rPr kumimoji="1" lang="ja-JP" altLang="en-US" smtClean="0"/>
              <a:t>2019/6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BCDFF46-DEED-F546-8FC8-891D8FBAAB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D177EC7-7F00-4D4A-BF46-4351C0FB87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3FBD9-4A29-6046-B486-46FA3AD1F3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82438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FA54BDC-D1C1-E34F-883D-FA05671E33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9426883-D1C4-6548-AA75-E9D1B014AC5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1B44B97-48B0-9B46-9E8A-3DFAB0A35C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9B71D-453C-4549-A402-6A7C1028A10F}" type="datetimeFigureOut">
              <a:rPr kumimoji="1" lang="ja-JP" altLang="en-US" smtClean="0"/>
              <a:t>2019/6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0D82852-3F07-3C4C-9637-89B177FA4A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F3CFE82-A202-604B-9370-B56FB31437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3FBD9-4A29-6046-B486-46FA3AD1F3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1350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3230EBA-61D2-3941-BAA4-9C11CA8A29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C3B587E-B0DD-4243-B34C-E38A76A8C0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1FDFEC7-E1BD-7C45-9B40-9E2DF8BB81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9B71D-453C-4549-A402-6A7C1028A10F}" type="datetimeFigureOut">
              <a:rPr kumimoji="1" lang="ja-JP" altLang="en-US" smtClean="0"/>
              <a:t>2019/6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656E1D9-4419-4C42-B6FE-A0AB89E228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92BBCE0-2823-2D47-90CE-98EE24F67E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3FBD9-4A29-6046-B486-46FA3AD1F3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21811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0D57BA6-5EEA-004C-9502-6270A80C0E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1B9C1BD-9A0C-A249-856D-458F2E5F05E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3658A0C-5DDC-1546-A80B-B26380B446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10CBBB3-332A-564B-BEBB-A0934AF71B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9B71D-453C-4549-A402-6A7C1028A10F}" type="datetimeFigureOut">
              <a:rPr kumimoji="1" lang="ja-JP" altLang="en-US" smtClean="0"/>
              <a:t>2019/6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968427B-A46D-E540-8AFF-64AF998434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672B5C9-EB66-7748-B500-48C99DA6CB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3FBD9-4A29-6046-B486-46FA3AD1F3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10733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D2FA822-ADE4-794A-812D-D58B672BFB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AF678A6-B9CB-B947-B6DB-7068A5E985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D2BDF5D-1554-EF43-8B41-C86A3A4E7C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48BC95E1-BCA6-0244-BC14-3BA1602A181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417E0A1B-F0F0-1740-A555-ED3FA749FC3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973FB0A-20C9-3940-9731-9D0842043B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9B71D-453C-4549-A402-6A7C1028A10F}" type="datetimeFigureOut">
              <a:rPr kumimoji="1" lang="ja-JP" altLang="en-US" smtClean="0"/>
              <a:t>2019/6/5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009BBC7E-AD9E-A74E-A5E8-EE42CCB4C1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6E92DD41-9700-844D-9D8F-616DD060F7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3FBD9-4A29-6046-B486-46FA3AD1F3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43246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8654619-2A3C-DE4D-8852-ABCA5F6AEC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F8E66F7-D9CE-CE4A-84FE-86B8CDE44F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9B71D-453C-4549-A402-6A7C1028A10F}" type="datetimeFigureOut">
              <a:rPr kumimoji="1" lang="ja-JP" altLang="en-US" smtClean="0"/>
              <a:t>2019/6/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BAEC0025-29BF-3E42-8EDE-5B0A078DE5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240B87F-AB91-1646-AD7A-894D6D9FB2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3FBD9-4A29-6046-B486-46FA3AD1F3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67840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73CE63DE-72D3-364B-86ED-3FC24FEBAE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9B71D-453C-4549-A402-6A7C1028A10F}" type="datetimeFigureOut">
              <a:rPr kumimoji="1" lang="ja-JP" altLang="en-US" smtClean="0"/>
              <a:t>2019/6/5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A4909DDC-6976-7C47-A34E-6CDC56B972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77546CB-7B45-0C45-BE14-6529650F3B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3FBD9-4A29-6046-B486-46FA3AD1F3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15794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FF73FED-F70E-0040-A492-AEBA263BE4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52EAC22-1AB1-BD4E-B4F0-38B2884DAA6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0D9455B-AC10-B04A-8DF3-739522BE51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09F2631-5F25-4944-9905-1D12DD4374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9B71D-453C-4549-A402-6A7C1028A10F}" type="datetimeFigureOut">
              <a:rPr kumimoji="1" lang="ja-JP" altLang="en-US" smtClean="0"/>
              <a:t>2019/6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7EBF58B-315D-6744-89E2-533756EEE7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A5EF531-56FC-9E44-9F54-5F0942B0A3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3FBD9-4A29-6046-B486-46FA3AD1F3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79718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117DA0B-FEF1-A440-87A2-4B34AE0920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CF2606DA-749C-A64B-8740-F0BD7E71528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D0E55FC-492A-E244-AD18-4AAE34F0B32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A5BDC22-2783-0D45-B453-E65C50AB7B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9B71D-453C-4549-A402-6A7C1028A10F}" type="datetimeFigureOut">
              <a:rPr kumimoji="1" lang="ja-JP" altLang="en-US" smtClean="0"/>
              <a:t>2019/6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F5F27FC-368E-BE44-BE9E-13BC1B3A53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E0CCFD9-66D0-EF4E-9D77-E89ACECFC4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3FBD9-4A29-6046-B486-46FA3AD1F3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02743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C963615-3854-A145-95EA-F78D5C692B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452C19D-89EA-C448-A2FB-6F3A4E0E7D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DC8F33E-5BEE-7F4A-9A40-A74A4117922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89B71D-453C-4549-A402-6A7C1028A10F}" type="datetimeFigureOut">
              <a:rPr kumimoji="1" lang="ja-JP" altLang="en-US" smtClean="0"/>
              <a:t>2019/6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CBAD139-DBDA-9B41-A48F-0E5CEFA4D79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EFB207F-1273-AC4B-9F3F-CE2FC6C8174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A3FBD9-4A29-6046-B486-46FA3AD1F3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24601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7" Type="http://schemas.openxmlformats.org/officeDocument/2006/relationships/image" Target="../media/image4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4.bin"/><Relationship Id="rId5" Type="http://schemas.openxmlformats.org/officeDocument/2006/relationships/image" Target="../media/image3.emf"/><Relationship Id="rId4" Type="http://schemas.openxmlformats.org/officeDocument/2006/relationships/oleObject" Target="../embeddings/oleObject3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.xml"/><Relationship Id="rId7" Type="http://schemas.openxmlformats.org/officeDocument/2006/relationships/image" Target="../media/image6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6.bin"/><Relationship Id="rId5" Type="http://schemas.openxmlformats.org/officeDocument/2006/relationships/image" Target="../media/image5.emf"/><Relationship Id="rId4" Type="http://schemas.openxmlformats.org/officeDocument/2006/relationships/oleObject" Target="../embeddings/oleObject5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9.bin"/><Relationship Id="rId3" Type="http://schemas.openxmlformats.org/officeDocument/2006/relationships/notesSlide" Target="../notesSlides/notesSlide4.xml"/><Relationship Id="rId7" Type="http://schemas.openxmlformats.org/officeDocument/2006/relationships/image" Target="../media/image8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oleObject" Target="../embeddings/oleObject8.bin"/><Relationship Id="rId5" Type="http://schemas.openxmlformats.org/officeDocument/2006/relationships/image" Target="../media/image7.emf"/><Relationship Id="rId4" Type="http://schemas.openxmlformats.org/officeDocument/2006/relationships/oleObject" Target="../embeddings/oleObject7.bin"/><Relationship Id="rId9" Type="http://schemas.openxmlformats.org/officeDocument/2006/relationships/image" Target="../media/image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A6239EC-3E3C-7C42-8133-010F8E7D7994}"/>
              </a:ext>
            </a:extLst>
          </p:cNvPr>
          <p:cNvSpPr txBox="1"/>
          <p:nvPr/>
        </p:nvSpPr>
        <p:spPr>
          <a:xfrm>
            <a:off x="874207" y="301451"/>
            <a:ext cx="11304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Helvetica" pitchFamily="2" charset="0"/>
              </a:rPr>
              <a:t>Figure 1A</a:t>
            </a:r>
            <a:endParaRPr lang="ja-JP" altLang="ja-JP" sz="1600" b="1" dirty="0">
              <a:latin typeface="Helvetica" pitchFamily="2" charset="0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A7E14395-7935-6F4B-B693-8A8EB718F4A3}"/>
              </a:ext>
            </a:extLst>
          </p:cNvPr>
          <p:cNvSpPr/>
          <p:nvPr/>
        </p:nvSpPr>
        <p:spPr>
          <a:xfrm>
            <a:off x="5851914" y="301451"/>
            <a:ext cx="113043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b="1" dirty="0">
                <a:latin typeface="Helvetica" pitchFamily="2" charset="0"/>
              </a:rPr>
              <a:t>Figure 1B</a:t>
            </a:r>
            <a:endParaRPr lang="ja-JP" altLang="ja-JP" sz="1600" b="1" dirty="0">
              <a:latin typeface="Helvetica" pitchFamily="2" charset="0"/>
            </a:endParaRPr>
          </a:p>
        </p:txBody>
      </p:sp>
      <p:graphicFrame>
        <p:nvGraphicFramePr>
          <p:cNvPr id="5" name="オブジェクト 4">
            <a:extLst>
              <a:ext uri="{FF2B5EF4-FFF2-40B4-BE49-F238E27FC236}">
                <a16:creationId xmlns:a16="http://schemas.microsoft.com/office/drawing/2014/main" id="{6123C140-9DB0-4851-8F0D-4FE335604B7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97161781"/>
              </p:ext>
            </p:extLst>
          </p:nvPr>
        </p:nvGraphicFramePr>
        <p:xfrm>
          <a:off x="1539473" y="1094533"/>
          <a:ext cx="3051866" cy="4866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6" name="Prism 7" r:id="rId4" imgW="4300741" imgH="6858053" progId="Prism7.Document">
                  <p:embed/>
                </p:oleObj>
              </mc:Choice>
              <mc:Fallback>
                <p:oleObj name="Prism 7" r:id="rId4" imgW="4300741" imgH="6858053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539473" y="1094533"/>
                        <a:ext cx="3051866" cy="4866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id="{C9F22DA3-E3F7-48E0-9862-2E7B4597128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23058685"/>
              </p:ext>
            </p:extLst>
          </p:nvPr>
        </p:nvGraphicFramePr>
        <p:xfrm>
          <a:off x="6095206" y="1190320"/>
          <a:ext cx="5014913" cy="4675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7" name="Prism 7" r:id="rId6" imgW="5014170" imgH="4674439" progId="Prism7.Document">
                  <p:embed/>
                </p:oleObj>
              </mc:Choice>
              <mc:Fallback>
                <p:oleObj name="Prism 7" r:id="rId6" imgW="5014170" imgH="4674439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095206" y="1190320"/>
                        <a:ext cx="5014913" cy="46751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868447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6247402-578C-3142-AA2E-814014F29F13}"/>
              </a:ext>
            </a:extLst>
          </p:cNvPr>
          <p:cNvSpPr txBox="1"/>
          <p:nvPr/>
        </p:nvSpPr>
        <p:spPr>
          <a:xfrm>
            <a:off x="874207" y="301451"/>
            <a:ext cx="11304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Helvetica" pitchFamily="2" charset="0"/>
              </a:rPr>
              <a:t>Figure 2A</a:t>
            </a:r>
            <a:endParaRPr lang="ja-JP" altLang="ja-JP" sz="1600" b="1" dirty="0">
              <a:latin typeface="Helvetica" pitchFamily="2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CF3C960-9D48-7143-A6EA-34D55A4CE067}"/>
              </a:ext>
            </a:extLst>
          </p:cNvPr>
          <p:cNvSpPr txBox="1"/>
          <p:nvPr/>
        </p:nvSpPr>
        <p:spPr>
          <a:xfrm>
            <a:off x="6391747" y="301451"/>
            <a:ext cx="16668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Helvetica" pitchFamily="2" charset="0"/>
              </a:rPr>
              <a:t>Figure 2B</a:t>
            </a:r>
            <a:endParaRPr lang="ja-JP" altLang="ja-JP" sz="1600" b="1" dirty="0">
              <a:latin typeface="Helvetica" pitchFamily="2" charset="0"/>
            </a:endParaRPr>
          </a:p>
        </p:txBody>
      </p:sp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id="{8A27552C-3F2A-4500-B44F-0A7DB13D0A2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5697874"/>
              </p:ext>
            </p:extLst>
          </p:nvPr>
        </p:nvGraphicFramePr>
        <p:xfrm>
          <a:off x="6836366" y="1232945"/>
          <a:ext cx="2971082" cy="45329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94" name="Prism 7" r:id="rId4" imgW="4608657" imgH="7033088" progId="Prism7.Document">
                  <p:embed/>
                </p:oleObj>
              </mc:Choice>
              <mc:Fallback>
                <p:oleObj name="Prism 7" r:id="rId4" imgW="4608657" imgH="7033088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836366" y="1232945"/>
                        <a:ext cx="2971082" cy="45329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オブジェクト 5">
            <a:extLst>
              <a:ext uri="{FF2B5EF4-FFF2-40B4-BE49-F238E27FC236}">
                <a16:creationId xmlns:a16="http://schemas.microsoft.com/office/drawing/2014/main" id="{B33DB5A4-E555-4DA9-B295-E987816B9C7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7977640"/>
              </p:ext>
            </p:extLst>
          </p:nvPr>
        </p:nvGraphicFramePr>
        <p:xfrm>
          <a:off x="1109338" y="1076190"/>
          <a:ext cx="4080970" cy="521270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95" name="Prism 7" r:id="rId6" imgW="5528083" imgH="7060820" progId="Prism7.Document">
                  <p:embed/>
                </p:oleObj>
              </mc:Choice>
              <mc:Fallback>
                <p:oleObj name="Prism 7" r:id="rId6" imgW="5528083" imgH="7060820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109338" y="1076190"/>
                        <a:ext cx="4080970" cy="521270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7489307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E18629A-78A4-0C47-AEB5-3D50FABDFC85}"/>
              </a:ext>
            </a:extLst>
          </p:cNvPr>
          <p:cNvSpPr txBox="1"/>
          <p:nvPr/>
        </p:nvSpPr>
        <p:spPr>
          <a:xfrm>
            <a:off x="874207" y="301451"/>
            <a:ext cx="11304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Helvetica" pitchFamily="2" charset="0"/>
              </a:rPr>
              <a:t>Figure 3A</a:t>
            </a:r>
            <a:endParaRPr lang="ja-JP" altLang="ja-JP" sz="1600" b="1" dirty="0">
              <a:latin typeface="Helvetica" pitchFamily="2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506C182-65CE-3C41-821E-3C912A872875}"/>
              </a:ext>
            </a:extLst>
          </p:cNvPr>
          <p:cNvSpPr txBox="1"/>
          <p:nvPr/>
        </p:nvSpPr>
        <p:spPr>
          <a:xfrm>
            <a:off x="6633588" y="301451"/>
            <a:ext cx="11304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Helvetica" pitchFamily="2" charset="0"/>
              </a:rPr>
              <a:t>Figure 3B</a:t>
            </a:r>
            <a:endParaRPr lang="ja-JP" altLang="ja-JP" sz="1600" b="1" dirty="0">
              <a:latin typeface="Helvetica" pitchFamily="2" charset="0"/>
            </a:endParaRPr>
          </a:p>
        </p:txBody>
      </p:sp>
      <p:graphicFrame>
        <p:nvGraphicFramePr>
          <p:cNvPr id="6" name="オブジェクト 5">
            <a:extLst>
              <a:ext uri="{FF2B5EF4-FFF2-40B4-BE49-F238E27FC236}">
                <a16:creationId xmlns:a16="http://schemas.microsoft.com/office/drawing/2014/main" id="{CF10F14C-F44E-4F52-A05D-2C5F6A47D8A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36239506"/>
              </p:ext>
            </p:extLst>
          </p:nvPr>
        </p:nvGraphicFramePr>
        <p:xfrm>
          <a:off x="1005840" y="975722"/>
          <a:ext cx="4471987" cy="41767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07" name="Prism 7" r:id="rId4" imgW="4471445" imgH="4175986" progId="Prism7.Document">
                  <p:embed/>
                </p:oleObj>
              </mc:Choice>
              <mc:Fallback>
                <p:oleObj name="Prism 7" r:id="rId4" imgW="4471445" imgH="4175986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005840" y="975722"/>
                        <a:ext cx="4471987" cy="41767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id="{D001AC3F-A4E8-4FD7-8E16-826C5771CD5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22173337"/>
              </p:ext>
            </p:extLst>
          </p:nvPr>
        </p:nvGraphicFramePr>
        <p:xfrm>
          <a:off x="6474014" y="1005789"/>
          <a:ext cx="5199063" cy="414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08" name="Prism 7" r:id="rId6" imgW="5198919" imgH="4148614" progId="Prism7.Document">
                  <p:embed/>
                </p:oleObj>
              </mc:Choice>
              <mc:Fallback>
                <p:oleObj name="Prism 7" r:id="rId6" imgW="5198919" imgH="4148614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474014" y="1005789"/>
                        <a:ext cx="5199063" cy="414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6451481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32C82A3-4687-DE41-9BA9-4C76651411E9}"/>
              </a:ext>
            </a:extLst>
          </p:cNvPr>
          <p:cNvSpPr txBox="1"/>
          <p:nvPr/>
        </p:nvSpPr>
        <p:spPr>
          <a:xfrm>
            <a:off x="874207" y="301451"/>
            <a:ext cx="11304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Helvetica" pitchFamily="2" charset="0"/>
              </a:rPr>
              <a:t>Figure 4A</a:t>
            </a:r>
            <a:endParaRPr lang="ja-JP" altLang="ja-JP" sz="1600" b="1" dirty="0">
              <a:latin typeface="Helvetica" pitchFamily="2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91B84D2-F5BF-F64E-96BC-8E05A403C367}"/>
              </a:ext>
            </a:extLst>
          </p:cNvPr>
          <p:cNvSpPr txBox="1"/>
          <p:nvPr/>
        </p:nvSpPr>
        <p:spPr>
          <a:xfrm>
            <a:off x="5269380" y="301453"/>
            <a:ext cx="11304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Helvetica" pitchFamily="2" charset="0"/>
              </a:rPr>
              <a:t>Figure 4B</a:t>
            </a:r>
            <a:endParaRPr lang="ja-JP" altLang="ja-JP" sz="1600" b="1" dirty="0">
              <a:latin typeface="Helvetica" pitchFamily="2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491B84D2-F5BF-F64E-96BC-8E05A403C367}"/>
              </a:ext>
            </a:extLst>
          </p:cNvPr>
          <p:cNvSpPr txBox="1"/>
          <p:nvPr/>
        </p:nvSpPr>
        <p:spPr>
          <a:xfrm>
            <a:off x="8754915" y="321121"/>
            <a:ext cx="11304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Helvetica" pitchFamily="2" charset="0"/>
              </a:rPr>
              <a:t>Figure 4C</a:t>
            </a:r>
            <a:endParaRPr lang="ja-JP" altLang="ja-JP" sz="1600" b="1" dirty="0">
              <a:latin typeface="Helvetica" pitchFamily="2" charset="0"/>
            </a:endParaRPr>
          </a:p>
        </p:txBody>
      </p:sp>
      <p:graphicFrame>
        <p:nvGraphicFramePr>
          <p:cNvPr id="6" name="オブジェクト 5">
            <a:extLst>
              <a:ext uri="{FF2B5EF4-FFF2-40B4-BE49-F238E27FC236}">
                <a16:creationId xmlns:a16="http://schemas.microsoft.com/office/drawing/2014/main" id="{FD732F27-5090-4521-B315-A23E80C41A0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23213906"/>
              </p:ext>
            </p:extLst>
          </p:nvPr>
        </p:nvGraphicFramePr>
        <p:xfrm>
          <a:off x="231309" y="667110"/>
          <a:ext cx="3661421" cy="42597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41" name="Prism 7" r:id="rId4" imgW="2933305" imgH="3413540" progId="Prism7.Document">
                  <p:embed/>
                </p:oleObj>
              </mc:Choice>
              <mc:Fallback>
                <p:oleObj name="Prism 7" r:id="rId4" imgW="2933305" imgH="3413540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31309" y="667110"/>
                        <a:ext cx="3661421" cy="42597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オブジェクト 8">
            <a:extLst>
              <a:ext uri="{FF2B5EF4-FFF2-40B4-BE49-F238E27FC236}">
                <a16:creationId xmlns:a16="http://schemas.microsoft.com/office/drawing/2014/main" id="{57EE2F2B-7312-45BA-ADA7-AC59E6B8F02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5630057"/>
              </p:ext>
            </p:extLst>
          </p:nvPr>
        </p:nvGraphicFramePr>
        <p:xfrm>
          <a:off x="7959636" y="710654"/>
          <a:ext cx="3283239" cy="42858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42" name="Prism 7" r:id="rId6" imgW="4715617" imgH="6155033" progId="Prism7.Document">
                  <p:embed/>
                </p:oleObj>
              </mc:Choice>
              <mc:Fallback>
                <p:oleObj name="Prism 7" r:id="rId6" imgW="4715617" imgH="6155033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7959636" y="710654"/>
                        <a:ext cx="3283239" cy="428589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オブジェクト 2">
            <a:extLst>
              <a:ext uri="{FF2B5EF4-FFF2-40B4-BE49-F238E27FC236}">
                <a16:creationId xmlns:a16="http://schemas.microsoft.com/office/drawing/2014/main" id="{353D60FA-EE2F-4D50-A24E-75FBE9CF8BF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82577108"/>
              </p:ext>
            </p:extLst>
          </p:nvPr>
        </p:nvGraphicFramePr>
        <p:xfrm>
          <a:off x="4541520" y="710654"/>
          <a:ext cx="3352799" cy="43761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43" name="Prism 7" r:id="rId8" imgW="4405900" imgH="5749499" progId="Prism7.Document">
                  <p:embed/>
                </p:oleObj>
              </mc:Choice>
              <mc:Fallback>
                <p:oleObj name="Prism 7" r:id="rId8" imgW="4405900" imgH="5749499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541520" y="710654"/>
                        <a:ext cx="3352799" cy="43761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0934815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158</TotalTime>
  <Words>22</Words>
  <Application>Microsoft Office PowerPoint</Application>
  <PresentationFormat>ワイド画面</PresentationFormat>
  <Paragraphs>13</Paragraphs>
  <Slides>4</Slides>
  <Notes>4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2</vt:i4>
      </vt:variant>
      <vt:variant>
        <vt:lpstr>スライド タイトル</vt:lpstr>
      </vt:variant>
      <vt:variant>
        <vt:i4>4</vt:i4>
      </vt:variant>
    </vt:vector>
  </HeadingPairs>
  <TitlesOfParts>
    <vt:vector size="11" baseType="lpstr">
      <vt:lpstr>游ゴシック</vt:lpstr>
      <vt:lpstr>游ゴシック Light</vt:lpstr>
      <vt:lpstr>Arial</vt:lpstr>
      <vt:lpstr>Helvetica</vt:lpstr>
      <vt:lpstr>Office テーマ</vt:lpstr>
      <vt:lpstr>Prism 7</vt:lpstr>
      <vt:lpstr>GraphPad Prism 7 プロジェクト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im3</cp:lastModifiedBy>
  <cp:revision>148</cp:revision>
  <cp:lastPrinted>2019-05-30T08:42:13Z</cp:lastPrinted>
  <dcterms:created xsi:type="dcterms:W3CDTF">2018-09-20T02:54:47Z</dcterms:created>
  <dcterms:modified xsi:type="dcterms:W3CDTF">2019-06-05T00:32:35Z</dcterms:modified>
</cp:coreProperties>
</file>